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2" d="100"/>
          <a:sy n="62" d="100"/>
        </p:scale>
        <p:origin x="300"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3B49C69-41AA-4D1E-9DF3-F77B3E46147B}" type="datetimeFigureOut">
              <a:rPr lang="en-US" smtClean="0"/>
              <a:t>12/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4090520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3B49C69-41AA-4D1E-9DF3-F77B3E46147B}" type="datetimeFigureOut">
              <a:rPr lang="en-US" smtClean="0"/>
              <a:t>12/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17707447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3B49C69-41AA-4D1E-9DF3-F77B3E46147B}" type="datetimeFigureOut">
              <a:rPr lang="en-US" smtClean="0"/>
              <a:t>12/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278173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3B49C69-41AA-4D1E-9DF3-F77B3E46147B}" type="datetimeFigureOut">
              <a:rPr lang="en-US" smtClean="0"/>
              <a:t>12/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3875543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3B49C69-41AA-4D1E-9DF3-F77B3E46147B}" type="datetimeFigureOut">
              <a:rPr lang="en-US" smtClean="0"/>
              <a:t>12/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40548497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3B49C69-41AA-4D1E-9DF3-F77B3E46147B}" type="datetimeFigureOut">
              <a:rPr lang="en-US" smtClean="0"/>
              <a:t>12/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5035662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3B49C69-41AA-4D1E-9DF3-F77B3E46147B}" type="datetimeFigureOut">
              <a:rPr lang="en-US" smtClean="0"/>
              <a:t>12/1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15265989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3B49C69-41AA-4D1E-9DF3-F77B3E46147B}" type="datetimeFigureOut">
              <a:rPr lang="en-US" smtClean="0"/>
              <a:t>12/1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29277395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B49C69-41AA-4D1E-9DF3-F77B3E46147B}" type="datetimeFigureOut">
              <a:rPr lang="en-US" smtClean="0"/>
              <a:t>12/1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5307468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3B49C69-41AA-4D1E-9DF3-F77B3E46147B}" type="datetimeFigureOut">
              <a:rPr lang="en-US" smtClean="0"/>
              <a:t>12/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1774474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3B49C69-41AA-4D1E-9DF3-F77B3E46147B}" type="datetimeFigureOut">
              <a:rPr lang="en-US" smtClean="0"/>
              <a:t>12/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D053B9-E3E4-442C-92B9-3FAE94DD8CCA}" type="slidenum">
              <a:rPr lang="en-US" smtClean="0"/>
              <a:t>‹#›</a:t>
            </a:fld>
            <a:endParaRPr lang="en-US"/>
          </a:p>
        </p:txBody>
      </p:sp>
    </p:spTree>
    <p:extLst>
      <p:ext uri="{BB962C8B-B14F-4D97-AF65-F5344CB8AC3E}">
        <p14:creationId xmlns:p14="http://schemas.microsoft.com/office/powerpoint/2010/main" val="15366267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B49C69-41AA-4D1E-9DF3-F77B3E46147B}" type="datetimeFigureOut">
              <a:rPr lang="en-US" smtClean="0"/>
              <a:t>12/17/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D053B9-E3E4-442C-92B9-3FAE94DD8CCA}" type="slidenum">
              <a:rPr lang="en-US" smtClean="0"/>
              <a:t>‹#›</a:t>
            </a:fld>
            <a:endParaRPr lang="en-US"/>
          </a:p>
        </p:txBody>
      </p:sp>
    </p:spTree>
    <p:extLst>
      <p:ext uri="{BB962C8B-B14F-4D97-AF65-F5344CB8AC3E}">
        <p14:creationId xmlns:p14="http://schemas.microsoft.com/office/powerpoint/2010/main" val="40590330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30FA0536-F7A3-4A4C-AE02-6BC96768BFE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269875"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pic>
        <p:nvPicPr>
          <p:cNvPr id="1025" name="Picture 3">
            <a:extLst>
              <a:ext uri="{FF2B5EF4-FFF2-40B4-BE49-F238E27FC236}">
                <a16:creationId xmlns:a16="http://schemas.microsoft.com/office/drawing/2014/main" id="{34DDB440-DA2F-45AE-9119-4F582738C20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05745" y="397827"/>
            <a:ext cx="10919810" cy="3737653"/>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879FF23F-2161-4464-808D-82AB7B633C4D}"/>
              </a:ext>
            </a:extLst>
          </p:cNvPr>
          <p:cNvSpPr>
            <a:spLocks noChangeArrowheads="1"/>
          </p:cNvSpPr>
          <p:nvPr/>
        </p:nvSpPr>
        <p:spPr bwMode="auto">
          <a:xfrm>
            <a:off x="503435" y="4591346"/>
            <a:ext cx="11322120" cy="17543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269875" algn="just" defTabSz="914400" rtl="0" eaLnBrk="0" fontAlgn="base" latinLnBrk="0" hangingPunct="0">
              <a:lnSpc>
                <a:spcPct val="100000"/>
              </a:lnSpc>
              <a:spcBef>
                <a:spcPct val="0"/>
              </a:spcBef>
              <a:spcAft>
                <a:spcPct val="0"/>
              </a:spcAft>
              <a:buClrTx/>
              <a:buSzTx/>
              <a:buFontTx/>
              <a:buNone/>
              <a:tabLst/>
            </a:pP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1. Generation of humanized mouse model. (A) Histogram of CD34+ cells isolated from human blood using CD34 microbeads. (B) Flow cytometry dot plots of blood cells used for the engraftment in humanized mice. Dot plot of proportion of human (Hu CD45) and mouse CD45 (</a:t>
            </a:r>
            <a:r>
              <a:rPr kumimoji="0" lang="en-US" altLang="en-US" b="0" i="0" u="none" strike="noStrike" cap="none" normalizeH="0" baseline="0" dirty="0" err="1">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s</a:t>
            </a: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D45) cells. Peripheral blood was collected from mice at 14 weeks post engraftment with human CD34+ HSCs and stained with antibodies to mouse (APC, red) and human CD45 (FITC, </a:t>
            </a:r>
            <a:r>
              <a:rPr lang="en-US" alt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green</a:t>
            </a: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he level of engraftment equal to % CD45+ human cells divided by the sum of % CD45+ human cells plus % CD45+ mouse cells.</a:t>
            </a:r>
            <a:endParaRPr kumimoji="0" lang="en-US" altLang="en-US"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646322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8581A291-B7BF-44A8-8A08-1C92A0CB141B}"/>
              </a:ext>
            </a:extLst>
          </p:cNvPr>
          <p:cNvSpPr txBox="1"/>
          <p:nvPr/>
        </p:nvSpPr>
        <p:spPr>
          <a:xfrm>
            <a:off x="-339047" y="4791646"/>
            <a:ext cx="11669405" cy="1671227"/>
          </a:xfrm>
          <a:prstGeom prst="rect">
            <a:avLst/>
          </a:prstGeom>
          <a:noFill/>
        </p:spPr>
        <p:txBody>
          <a:bodyPr wrap="square">
            <a:spAutoFit/>
          </a:bodyPr>
          <a:lstStyle/>
          <a:p>
            <a:pPr marL="1656080" marR="0" indent="269875" algn="just">
              <a:lnSpc>
                <a:spcPct val="95000"/>
              </a:lnSpc>
              <a:spcBef>
                <a:spcPts val="0"/>
              </a:spcBef>
              <a:spcAft>
                <a:spcPts val="0"/>
              </a:spcAft>
            </a:pP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2. Agarose Gel electrophoresis of colony PCR  for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Δ</a:t>
            </a:r>
            <a:r>
              <a:rPr lang="en-US" sz="1800" i="1"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vraR</a:t>
            </a:r>
            <a:r>
              <a:rPr lang="en-US" sz="1800" i="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gene knockout confirmation. (A) Lane 1 is the 100 bp ladder and lane 2 is the 200 bp amplicon for wildtype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vraR</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B) Lane 1 is the 100 bp ladder and lane 2 is the 1100 bp amplicon for mutant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vraR</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with intron insertion. (C) Lane 1 is the 100  bp ladder, lane 2 is the  550 bp   PCR amplicon (positive control) using pNL9164 seq F and pNl9164 seq R primers as the positive control, and lane 3 showing the  absence of the amplicon band confirming the curing of pNL9164  plasmid in knockout clone </a:t>
            </a:r>
          </a:p>
        </p:txBody>
      </p:sp>
      <p:pic>
        <p:nvPicPr>
          <p:cNvPr id="4" name="Picture 3">
            <a:extLst>
              <a:ext uri="{FF2B5EF4-FFF2-40B4-BE49-F238E27FC236}">
                <a16:creationId xmlns:a16="http://schemas.microsoft.com/office/drawing/2014/main" id="{8FE712F9-F749-4F2C-9C7D-CDBB588988BF}"/>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511423" y="395127"/>
            <a:ext cx="5365750" cy="4165600"/>
          </a:xfrm>
          <a:prstGeom prst="rect">
            <a:avLst/>
          </a:prstGeom>
          <a:noFill/>
          <a:ln>
            <a:noFill/>
          </a:ln>
        </p:spPr>
      </p:pic>
    </p:spTree>
    <p:extLst>
      <p:ext uri="{BB962C8B-B14F-4D97-AF65-F5344CB8AC3E}">
        <p14:creationId xmlns:p14="http://schemas.microsoft.com/office/powerpoint/2010/main" val="14139270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08B5656C-F0DD-4EE3-878D-69741FEE2556}"/>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2049" name="Picture 22">
            <a:extLst>
              <a:ext uri="{FF2B5EF4-FFF2-40B4-BE49-F238E27FC236}">
                <a16:creationId xmlns:a16="http://schemas.microsoft.com/office/drawing/2014/main" id="{CD53471C-C863-4468-BBF8-09302CC2CFD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85338" y="457200"/>
            <a:ext cx="7206245" cy="4661899"/>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49310C37-CD68-4E68-868E-119A07D9AB05}"/>
              </a:ext>
            </a:extLst>
          </p:cNvPr>
          <p:cNvSpPr>
            <a:spLocks noChangeArrowheads="1"/>
          </p:cNvSpPr>
          <p:nvPr/>
        </p:nvSpPr>
        <p:spPr bwMode="auto">
          <a:xfrm>
            <a:off x="904126" y="5477470"/>
            <a:ext cx="10757042" cy="9233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269875" algn="l" defTabSz="914400" rtl="0" eaLnBrk="0" fontAlgn="base" latinLnBrk="0" hangingPunct="0">
              <a:lnSpc>
                <a:spcPct val="100000"/>
              </a:lnSpc>
              <a:spcBef>
                <a:spcPct val="0"/>
              </a:spcBef>
              <a:spcAft>
                <a:spcPct val="0"/>
              </a:spcAft>
              <a:buClrTx/>
              <a:buSzTx/>
              <a:buFontTx/>
              <a:buNone/>
              <a:tabLst/>
            </a:pP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3. Cytokine responses in humanized mice. Humanized mice were infected with 10</a:t>
            </a:r>
            <a:r>
              <a:rPr kumimoji="0" lang="en-US" altLang="en-US" b="0" i="0" u="none" strike="noStrike" cap="none" normalizeH="0" baseline="3000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a:t>
            </a: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FU MRSA. (A) Human TNF-α, (B) IL-6, (C) IL-1β and (D) IL-8. Data are expressed as mean ± SD from one representative experiment. *</a:t>
            </a:r>
            <a:r>
              <a:rPr kumimoji="0" lang="en-US" altLang="en-US" b="0" i="1"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 </a:t>
            </a:r>
            <a:r>
              <a:rPr kumimoji="0" lang="en-US" altLang="en-US"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t; 0.05</a:t>
            </a:r>
            <a:endParaRPr kumimoji="0" lang="en-US" altLang="en-US"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411504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1</TotalTime>
  <Words>299</Words>
  <Application>Microsoft Office PowerPoint</Application>
  <PresentationFormat>Widescreen</PresentationFormat>
  <Paragraphs>4</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Nilakshi Barua (MIC)</cp:lastModifiedBy>
  <cp:revision>26</cp:revision>
  <dcterms:created xsi:type="dcterms:W3CDTF">2019-07-02T04:29:44Z</dcterms:created>
  <dcterms:modified xsi:type="dcterms:W3CDTF">2021-12-17T08:10:39Z</dcterms:modified>
</cp:coreProperties>
</file>